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9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95EB3-908D-4CBB-865C-26337106C361}" type="datetimeFigureOut">
              <a:rPr lang="zh-CN" altLang="en-US" smtClean="0"/>
              <a:t>2018/1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04D1-4D4D-4764-88F3-36BC89A61B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7801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95EB3-908D-4CBB-865C-26337106C361}" type="datetimeFigureOut">
              <a:rPr lang="zh-CN" altLang="en-US" smtClean="0"/>
              <a:t>2018/1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04D1-4D4D-4764-88F3-36BC89A61B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7542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95EB3-908D-4CBB-865C-26337106C361}" type="datetimeFigureOut">
              <a:rPr lang="zh-CN" altLang="en-US" smtClean="0"/>
              <a:t>2018/1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04D1-4D4D-4764-88F3-36BC89A61B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0007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95EB3-908D-4CBB-865C-26337106C361}" type="datetimeFigureOut">
              <a:rPr lang="zh-CN" altLang="en-US" smtClean="0"/>
              <a:t>2018/1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04D1-4D4D-4764-88F3-36BC89A61B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3719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95EB3-908D-4CBB-865C-26337106C361}" type="datetimeFigureOut">
              <a:rPr lang="zh-CN" altLang="en-US" smtClean="0"/>
              <a:t>2018/1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04D1-4D4D-4764-88F3-36BC89A61B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40037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95EB3-908D-4CBB-865C-26337106C361}" type="datetimeFigureOut">
              <a:rPr lang="zh-CN" altLang="en-US" smtClean="0"/>
              <a:t>2018/11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04D1-4D4D-4764-88F3-36BC89A61B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6646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95EB3-908D-4CBB-865C-26337106C361}" type="datetimeFigureOut">
              <a:rPr lang="zh-CN" altLang="en-US" smtClean="0"/>
              <a:t>2018/11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04D1-4D4D-4764-88F3-36BC89A61B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8710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95EB3-908D-4CBB-865C-26337106C361}" type="datetimeFigureOut">
              <a:rPr lang="zh-CN" altLang="en-US" smtClean="0"/>
              <a:t>2018/11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04D1-4D4D-4764-88F3-36BC89A61B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6503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95EB3-908D-4CBB-865C-26337106C361}" type="datetimeFigureOut">
              <a:rPr lang="zh-CN" altLang="en-US" smtClean="0"/>
              <a:t>2018/11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04D1-4D4D-4764-88F3-36BC89A61B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4964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95EB3-908D-4CBB-865C-26337106C361}" type="datetimeFigureOut">
              <a:rPr lang="zh-CN" altLang="en-US" smtClean="0"/>
              <a:t>2018/11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04D1-4D4D-4764-88F3-36BC89A61B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1479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95EB3-908D-4CBB-865C-26337106C361}" type="datetimeFigureOut">
              <a:rPr lang="zh-CN" altLang="en-US" smtClean="0"/>
              <a:t>2018/11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304D1-4D4D-4764-88F3-36BC89A61B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8842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B95EB3-908D-4CBB-865C-26337106C361}" type="datetimeFigureOut">
              <a:rPr lang="zh-CN" altLang="en-US" smtClean="0"/>
              <a:t>2018/1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A304D1-4D4D-4764-88F3-36BC89A61B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47282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3360" y="314006"/>
            <a:ext cx="3600000" cy="2400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3337" y="314006"/>
            <a:ext cx="3600000" cy="24000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3360" y="3372363"/>
            <a:ext cx="3600000" cy="2400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3337" y="3509963"/>
            <a:ext cx="3600000" cy="2400000"/>
          </a:xfrm>
          <a:prstGeom prst="rect">
            <a:avLst/>
          </a:prstGeom>
        </p:spPr>
      </p:pic>
      <p:sp>
        <p:nvSpPr>
          <p:cNvPr id="14" name="矩形 13"/>
          <p:cNvSpPr/>
          <p:nvPr/>
        </p:nvSpPr>
        <p:spPr>
          <a:xfrm>
            <a:off x="1323360" y="2806081"/>
            <a:ext cx="32590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S9</a:t>
            </a:r>
            <a:r>
              <a:rPr lang="en-US" altLang="zh-CN" dirty="0" smtClean="0"/>
              <a:t>-Heart-PBS</a:t>
            </a:r>
            <a:endParaRPr lang="zh-CN" altLang="en-US" dirty="0"/>
          </a:p>
        </p:txBody>
      </p:sp>
      <p:sp>
        <p:nvSpPr>
          <p:cNvPr id="15" name="矩形 14"/>
          <p:cNvSpPr/>
          <p:nvPr/>
        </p:nvSpPr>
        <p:spPr>
          <a:xfrm>
            <a:off x="6903788" y="2855421"/>
            <a:ext cx="35235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S9</a:t>
            </a:r>
            <a:r>
              <a:rPr lang="en-US" altLang="zh-CN" dirty="0" smtClean="0"/>
              <a:t>-Heart-SCNGs</a:t>
            </a:r>
            <a:endParaRPr lang="zh-CN" altLang="en-US" dirty="0"/>
          </a:p>
        </p:txBody>
      </p:sp>
      <p:sp>
        <p:nvSpPr>
          <p:cNvPr id="16" name="矩形 15"/>
          <p:cNvSpPr/>
          <p:nvPr/>
        </p:nvSpPr>
        <p:spPr>
          <a:xfrm>
            <a:off x="1173360" y="6025570"/>
            <a:ext cx="33666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S9</a:t>
            </a:r>
            <a:r>
              <a:rPr lang="en-US" altLang="zh-CN" dirty="0" smtClean="0"/>
              <a:t>-Kidney-PBS</a:t>
            </a:r>
            <a:endParaRPr lang="zh-CN" altLang="en-US" dirty="0"/>
          </a:p>
        </p:txBody>
      </p:sp>
      <p:sp>
        <p:nvSpPr>
          <p:cNvPr id="17" name="矩形 16"/>
          <p:cNvSpPr/>
          <p:nvPr/>
        </p:nvSpPr>
        <p:spPr>
          <a:xfrm>
            <a:off x="6753788" y="6074910"/>
            <a:ext cx="36311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S9</a:t>
            </a:r>
            <a:r>
              <a:rPr lang="en-US" altLang="zh-CN" dirty="0" smtClean="0"/>
              <a:t>-Kidney-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549422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6902" y="564083"/>
            <a:ext cx="3600000" cy="2400000"/>
          </a:xfr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3549" y="549773"/>
            <a:ext cx="3600000" cy="241431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6902" y="3701640"/>
            <a:ext cx="3600000" cy="240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3549" y="3764555"/>
            <a:ext cx="3600000" cy="2400000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983726" y="3123525"/>
            <a:ext cx="31799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S9</a:t>
            </a:r>
            <a:r>
              <a:rPr lang="en-US" altLang="zh-CN" dirty="0" smtClean="0"/>
              <a:t>-Liver-PBS</a:t>
            </a:r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6564154" y="3172865"/>
            <a:ext cx="34444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S9</a:t>
            </a:r>
            <a:r>
              <a:rPr lang="en-US" altLang="zh-CN" dirty="0" smtClean="0"/>
              <a:t>-Liver-SCNGs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>
            <a:off x="983726" y="6310423"/>
            <a:ext cx="31821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S9</a:t>
            </a:r>
            <a:r>
              <a:rPr lang="en-US" altLang="zh-CN" dirty="0" smtClean="0"/>
              <a:t>-Lung-PBS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6564154" y="6359763"/>
            <a:ext cx="34466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S9</a:t>
            </a:r>
            <a:r>
              <a:rPr lang="en-US" altLang="zh-CN" dirty="0" smtClean="0"/>
              <a:t>-Lung-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287735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9596" y="1269633"/>
            <a:ext cx="3600000" cy="2414310"/>
          </a:xfr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3482" y="1269633"/>
            <a:ext cx="3600000" cy="2414310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1123063" y="4354445"/>
            <a:ext cx="33648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S9</a:t>
            </a:r>
            <a:r>
              <a:rPr lang="en-US" altLang="zh-CN" dirty="0" smtClean="0"/>
              <a:t>-Spleen-PBS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6703491" y="4403785"/>
            <a:ext cx="36293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S9</a:t>
            </a:r>
            <a:r>
              <a:rPr lang="en-US" altLang="zh-CN" dirty="0" smtClean="0"/>
              <a:t>-Spleen-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22899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70</Words>
  <Application>Microsoft Office PowerPoint</Application>
  <PresentationFormat>宽屏</PresentationFormat>
  <Paragraphs>10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霞</dc:creator>
  <cp:lastModifiedBy>王 霞</cp:lastModifiedBy>
  <cp:revision>3</cp:revision>
  <dcterms:created xsi:type="dcterms:W3CDTF">2018-11-12T02:30:53Z</dcterms:created>
  <dcterms:modified xsi:type="dcterms:W3CDTF">2018-11-12T02:45:59Z</dcterms:modified>
</cp:coreProperties>
</file>